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7" d="100"/>
          <a:sy n="67" d="100"/>
        </p:scale>
        <p:origin x="-216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EBC29-0CA6-944B-99C6-C2B32A1DC7EE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A458B-1B53-384F-8D4A-C5A58D84D9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4558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EBC29-0CA6-944B-99C6-C2B32A1DC7EE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A458B-1B53-384F-8D4A-C5A58D84D9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0845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EBC29-0CA6-944B-99C6-C2B32A1DC7EE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A458B-1B53-384F-8D4A-C5A58D84D9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8334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EBC29-0CA6-944B-99C6-C2B32A1DC7EE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A458B-1B53-384F-8D4A-C5A58D84D9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5734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EBC29-0CA6-944B-99C6-C2B32A1DC7EE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A458B-1B53-384F-8D4A-C5A58D84D9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004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EBC29-0CA6-944B-99C6-C2B32A1DC7EE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A458B-1B53-384F-8D4A-C5A58D84D9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8627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EBC29-0CA6-944B-99C6-C2B32A1DC7EE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A458B-1B53-384F-8D4A-C5A58D84D9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4839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EBC29-0CA6-944B-99C6-C2B32A1DC7EE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A458B-1B53-384F-8D4A-C5A58D84D9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0225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EBC29-0CA6-944B-99C6-C2B32A1DC7EE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A458B-1B53-384F-8D4A-C5A58D84D9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6808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EBC29-0CA6-944B-99C6-C2B32A1DC7EE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A458B-1B53-384F-8D4A-C5A58D84D9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959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EBC29-0CA6-944B-99C6-C2B32A1DC7EE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A458B-1B53-384F-8D4A-C5A58D84D9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777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BEBC29-0CA6-944B-99C6-C2B32A1DC7EE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4A458B-1B53-384F-8D4A-C5A58D84D9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6924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r 1"/>
          <p:cNvGrpSpPr>
            <a:grpSpLocks noChangeAspect="1"/>
          </p:cNvGrpSpPr>
          <p:nvPr/>
        </p:nvGrpSpPr>
        <p:grpSpPr>
          <a:xfrm>
            <a:off x="362796" y="703433"/>
            <a:ext cx="8605680" cy="5652000"/>
            <a:chOff x="362799" y="485540"/>
            <a:chExt cx="8361209" cy="6114916"/>
          </a:xfrm>
        </p:grpSpPr>
        <p:pic>
          <p:nvPicPr>
            <p:cNvPr id="4" name="Picture 3" descr="FigureFEA.pd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8140" y="485540"/>
              <a:ext cx="6538107" cy="404545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" name="Rectangle 4"/>
            <p:cNvSpPr/>
            <p:nvPr/>
          </p:nvSpPr>
          <p:spPr>
            <a:xfrm>
              <a:off x="3061574" y="1248783"/>
              <a:ext cx="528294" cy="108000"/>
            </a:xfrm>
            <a:prstGeom prst="rect">
              <a:avLst/>
            </a:prstGeom>
            <a:noFill/>
            <a:ln w="12700" cmpd="sng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rgbClr val="FF0000"/>
                  </a:solidFill>
                </a:ln>
                <a:noFill/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3801554" y="1752632"/>
              <a:ext cx="533380" cy="108000"/>
            </a:xfrm>
            <a:prstGeom prst="rect">
              <a:avLst/>
            </a:prstGeom>
            <a:noFill/>
            <a:ln w="12700" cmpd="sng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rgbClr val="FF0000"/>
                  </a:solidFill>
                </a:ln>
                <a:noFill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3801553" y="1625924"/>
              <a:ext cx="533381" cy="126707"/>
            </a:xfrm>
            <a:prstGeom prst="rect">
              <a:avLst/>
            </a:prstGeom>
            <a:noFill/>
            <a:ln w="12700" cmpd="sng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rgbClr val="FF0000"/>
                  </a:solidFill>
                </a:ln>
                <a:noFill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838199" y="4939555"/>
              <a:ext cx="5118779" cy="166090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/>
            <p:cNvSpPr>
              <a:spLocks/>
            </p:cNvSpPr>
            <p:nvPr/>
          </p:nvSpPr>
          <p:spPr>
            <a:xfrm>
              <a:off x="3315243" y="5619517"/>
              <a:ext cx="1080000" cy="23676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 smtClean="0"/>
                <a:t>FEA1</a:t>
              </a:r>
              <a:endParaRPr lang="en-US" sz="1600" dirty="0"/>
            </a:p>
          </p:txBody>
        </p:sp>
        <p:sp>
          <p:nvSpPr>
            <p:cNvPr id="10" name="Rectangle 9"/>
            <p:cNvSpPr>
              <a:spLocks/>
            </p:cNvSpPr>
            <p:nvPr/>
          </p:nvSpPr>
          <p:spPr>
            <a:xfrm>
              <a:off x="3213196" y="6024649"/>
              <a:ext cx="863998" cy="23676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 smtClean="0"/>
                <a:t>FEA1</a:t>
              </a:r>
              <a:endParaRPr lang="en-US" sz="1600" dirty="0"/>
            </a:p>
          </p:txBody>
        </p:sp>
        <p:cxnSp>
          <p:nvCxnSpPr>
            <p:cNvPr id="11" name="Straight Connector 10"/>
            <p:cNvCxnSpPr/>
            <p:nvPr/>
          </p:nvCxnSpPr>
          <p:spPr>
            <a:xfrm flipH="1">
              <a:off x="2661359" y="5748661"/>
              <a:ext cx="650206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H="1">
              <a:off x="4395244" y="5739635"/>
              <a:ext cx="254204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 flipH="1">
              <a:off x="2670990" y="6166289"/>
              <a:ext cx="542206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flipH="1">
              <a:off x="4077574" y="6166289"/>
              <a:ext cx="74203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Rectangle 14"/>
            <p:cNvSpPr>
              <a:spLocks/>
            </p:cNvSpPr>
            <p:nvPr/>
          </p:nvSpPr>
          <p:spPr>
            <a:xfrm>
              <a:off x="4152556" y="6024649"/>
              <a:ext cx="1259993" cy="23676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 smtClean="0"/>
                <a:t>FEA1</a:t>
              </a:r>
              <a:endParaRPr lang="en-US" sz="1600" dirty="0"/>
            </a:p>
          </p:txBody>
        </p:sp>
        <p:cxnSp>
          <p:nvCxnSpPr>
            <p:cNvPr id="16" name="Straight Connector 15"/>
            <p:cNvCxnSpPr/>
            <p:nvPr/>
          </p:nvCxnSpPr>
          <p:spPr>
            <a:xfrm flipH="1">
              <a:off x="5412549" y="6139211"/>
              <a:ext cx="254204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flipH="1">
              <a:off x="4565727" y="5676800"/>
              <a:ext cx="1" cy="125671"/>
            </a:xfrm>
            <a:prstGeom prst="line">
              <a:avLst/>
            </a:prstGeom>
            <a:ln w="76200" cmpd="sng">
              <a:solidFill>
                <a:schemeClr val="accent6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H="1">
              <a:off x="5579096" y="6072907"/>
              <a:ext cx="1" cy="125671"/>
            </a:xfrm>
            <a:prstGeom prst="line">
              <a:avLst/>
            </a:prstGeom>
            <a:ln w="76200" cmpd="sng">
              <a:solidFill>
                <a:schemeClr val="accent6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Rectangle 18"/>
            <p:cNvSpPr>
              <a:spLocks/>
            </p:cNvSpPr>
            <p:nvPr/>
          </p:nvSpPr>
          <p:spPr>
            <a:xfrm>
              <a:off x="2667244" y="5233824"/>
              <a:ext cx="1295998" cy="23676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 smtClean="0"/>
                <a:t>FEA1</a:t>
              </a:r>
              <a:endParaRPr lang="en-US" sz="1600" dirty="0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1029177" y="5147728"/>
              <a:ext cx="156865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i="1" dirty="0" smtClean="0"/>
                <a:t>Ch. reinhardtii</a:t>
              </a:r>
              <a:endParaRPr lang="en-US" i="1" dirty="0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1044664" y="5974076"/>
              <a:ext cx="94942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i="1" dirty="0" smtClean="0"/>
                <a:t>O. tauri</a:t>
              </a:r>
              <a:endParaRPr lang="en-US" i="1" dirty="0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1039939" y="5556351"/>
              <a:ext cx="158984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i="1" dirty="0" smtClean="0"/>
                <a:t>P. </a:t>
              </a:r>
              <a:r>
                <a:rPr lang="en-US" i="1" dirty="0" err="1" smtClean="0"/>
                <a:t>tricornutum</a:t>
              </a:r>
              <a:endParaRPr lang="en-US" i="1" dirty="0"/>
            </a:p>
          </p:txBody>
        </p:sp>
        <p:cxnSp>
          <p:nvCxnSpPr>
            <p:cNvPr id="23" name="Straight Connector 22"/>
            <p:cNvCxnSpPr/>
            <p:nvPr/>
          </p:nvCxnSpPr>
          <p:spPr>
            <a:xfrm flipH="1">
              <a:off x="2670990" y="6046753"/>
              <a:ext cx="1" cy="251998"/>
            </a:xfrm>
            <a:prstGeom prst="line">
              <a:avLst/>
            </a:prstGeom>
            <a:ln w="76200" cmpd="sng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 flipH="1">
              <a:off x="2684091" y="5629124"/>
              <a:ext cx="1" cy="252000"/>
            </a:xfrm>
            <a:prstGeom prst="line">
              <a:avLst/>
            </a:prstGeom>
            <a:ln w="76200" cmpd="sng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2684093" y="5222483"/>
              <a:ext cx="0" cy="252000"/>
            </a:xfrm>
            <a:prstGeom prst="line">
              <a:avLst/>
            </a:prstGeom>
            <a:ln w="76200" cmpd="sng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 flipH="1">
              <a:off x="6287435" y="5333210"/>
              <a:ext cx="1" cy="251998"/>
            </a:xfrm>
            <a:prstGeom prst="line">
              <a:avLst/>
            </a:prstGeom>
            <a:ln w="76200" cmpd="sng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Rectangle 26"/>
            <p:cNvSpPr/>
            <p:nvPr/>
          </p:nvSpPr>
          <p:spPr>
            <a:xfrm>
              <a:off x="6261088" y="5638423"/>
              <a:ext cx="234862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smtClean="0"/>
                <a:t>- </a:t>
              </a:r>
              <a:r>
                <a:rPr lang="en-US" sz="1600" dirty="0" err="1" smtClean="0"/>
                <a:t>Transmembrane</a:t>
              </a:r>
              <a:r>
                <a:rPr lang="en-US" sz="1600" dirty="0" smtClean="0"/>
                <a:t> domain</a:t>
              </a:r>
              <a:endParaRPr lang="en-US" sz="1600" dirty="0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6287436" y="5253830"/>
              <a:ext cx="147328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smtClean="0"/>
                <a:t>- Signal peptide</a:t>
              </a:r>
              <a:endParaRPr lang="en-US" sz="1600" dirty="0"/>
            </a:p>
          </p:txBody>
        </p:sp>
        <p:cxnSp>
          <p:nvCxnSpPr>
            <p:cNvPr id="29" name="Straight Connector 28"/>
            <p:cNvCxnSpPr/>
            <p:nvPr/>
          </p:nvCxnSpPr>
          <p:spPr>
            <a:xfrm flipH="1">
              <a:off x="6286487" y="5765376"/>
              <a:ext cx="1" cy="125671"/>
            </a:xfrm>
            <a:prstGeom prst="line">
              <a:avLst/>
            </a:prstGeom>
            <a:ln w="76200" cmpd="sng">
              <a:solidFill>
                <a:schemeClr val="accent6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Rectangle 29"/>
            <p:cNvSpPr/>
            <p:nvPr/>
          </p:nvSpPr>
          <p:spPr>
            <a:xfrm>
              <a:off x="6164618" y="5283968"/>
              <a:ext cx="2559390" cy="78893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32" name="ZoneTexte 74"/>
            <p:cNvSpPr txBox="1"/>
            <p:nvPr/>
          </p:nvSpPr>
          <p:spPr>
            <a:xfrm>
              <a:off x="362799" y="501599"/>
              <a:ext cx="300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A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3" name="ZoneTexte 74"/>
            <p:cNvSpPr txBox="1"/>
            <p:nvPr/>
          </p:nvSpPr>
          <p:spPr>
            <a:xfrm>
              <a:off x="362799" y="4985584"/>
              <a:ext cx="287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B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sp>
        <p:nvSpPr>
          <p:cNvPr id="35" name="ZoneTexte 34"/>
          <p:cNvSpPr txBox="1"/>
          <p:nvPr/>
        </p:nvSpPr>
        <p:spPr>
          <a:xfrm>
            <a:off x="1316" y="0"/>
            <a:ext cx="9374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Figure S10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8798960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3</Words>
  <Application>Microsoft Macintosh PowerPoint</Application>
  <PresentationFormat>Présentation à l'écran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suisse</dc:creator>
  <cp:lastModifiedBy>Lesuisse</cp:lastModifiedBy>
  <cp:revision>1</cp:revision>
  <dcterms:created xsi:type="dcterms:W3CDTF">2016-02-08T11:47:12Z</dcterms:created>
  <dcterms:modified xsi:type="dcterms:W3CDTF">2016-02-08T11:48:19Z</dcterms:modified>
</cp:coreProperties>
</file>